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287856-D340-4B20-86BE-2B434430D66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1127160" y="703440"/>
            <a:ext cx="4595760" cy="344628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921960" y="4361040"/>
            <a:ext cx="5000760" cy="40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o visualise the overall rsponse of gene expre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o find coherent temporal patterns we subdivided genes into categories using k-means Clustering. The LPA responsive genes could be grouped into immediate early genes (0.5-1 h), early genes (maximum at 2 hours), genes that peak from 2-6 hours and transcripts that remained at high or low levels lasting up to 24 hours. Most genes fall into the categories from 2-6 hour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670D89-7968-4F02-8D7C-FDC83C2B00C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34460-68BD-4B85-8724-5ADDC4C259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A64E07-FB51-45EB-BE32-B46F971714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CB88A4-986B-45CC-A404-61412211B0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886839-D449-4EE9-8BE8-CC5B28E9B4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90D512-7E62-498F-9B1C-248284FF51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F26C2-89B6-4E18-9C87-7083636085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2293F-D8AA-4F19-9684-D7DD0A2D72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E17271-8F15-416B-946B-9949E89999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2ADF3-141C-49F3-A873-6D800AFCC2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5051E-12BB-427C-87B0-F6A93D94D8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84E06-8693-4223-BB7C-42DE935CB4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C57201-03B7-4549-9E30-095EF0FA4E2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469800" y="228600"/>
            <a:ext cx="8534520" cy="5410080"/>
          </a:xfrm>
          <a:prstGeom prst="rect">
            <a:avLst/>
          </a:prstGeom>
          <a:gradFill rotWithShape="0">
            <a:gsLst>
              <a:gs pos="0">
                <a:srgbClr val="ff3300"/>
              </a:gs>
              <a:gs pos="100000">
                <a:srgbClr val="00cc00"/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315200" y="3319560"/>
            <a:ext cx="861840" cy="26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nl-NL" sz="1400" spc="-1" strike="noStrike">
                <a:solidFill>
                  <a:srgbClr val="000000"/>
                </a:solidFill>
                <a:latin typeface="Arial"/>
              </a:rPr>
              <a:t>4-24 hrs</a:t>
            </a:r>
            <a:r>
              <a:rPr b="1" lang="nl-NL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209760" y="3606840"/>
            <a:ext cx="457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543640" y="3602160"/>
            <a:ext cx="457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666880" y="1825560"/>
            <a:ext cx="3733920" cy="307080"/>
          </a:xfrm>
          <a:prstGeom prst="rect">
            <a:avLst/>
          </a:prstGeom>
          <a:solidFill>
            <a:srgbClr val="ffffff"/>
          </a:solidFill>
          <a:ln w="9360">
            <a:solidFill>
              <a:srgbClr val="33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hape chang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33520" y="380880"/>
            <a:ext cx="2286000" cy="1159560"/>
          </a:xfrm>
          <a:prstGeom prst="rect">
            <a:avLst/>
          </a:prstGeom>
          <a:solidFill>
            <a:srgbClr val="ffffff"/>
          </a:solidFill>
          <a:ln w="9360">
            <a:solidFill>
              <a:srgbClr val="33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ranscription facto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x-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hemokine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rowth facto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85800" y="2133720"/>
            <a:ext cx="1905120" cy="946440"/>
          </a:xfrm>
          <a:prstGeom prst="rect">
            <a:avLst/>
          </a:prstGeom>
          <a:solidFill>
            <a:srgbClr val="ffffff"/>
          </a:solidFill>
          <a:ln w="9360">
            <a:solidFill>
              <a:srgbClr val="33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ell morpholog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Protein and lipid biosysnthe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666880" y="457200"/>
            <a:ext cx="1981440" cy="1372680"/>
          </a:xfrm>
          <a:prstGeom prst="rect">
            <a:avLst/>
          </a:prstGeom>
          <a:solidFill>
            <a:srgbClr val="ffffff"/>
          </a:solidFill>
          <a:ln w="9360">
            <a:solidFill>
              <a:srgbClr val="33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edback regulato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hemokines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ngiogenic factors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ro-fibrotic facto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AI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419720" y="2365200"/>
            <a:ext cx="3809880" cy="946440"/>
          </a:xfrm>
          <a:prstGeom prst="rect">
            <a:avLst/>
          </a:prstGeom>
          <a:solidFill>
            <a:srgbClr val="ffffff"/>
          </a:solidFill>
          <a:ln w="9360">
            <a:solidFill>
              <a:srgbClr val="33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atrix remodel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etalloproteas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ell move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724280" y="533520"/>
            <a:ext cx="2667240" cy="733320"/>
          </a:xfrm>
          <a:prstGeom prst="rect">
            <a:avLst/>
          </a:prstGeom>
          <a:solidFill>
            <a:srgbClr val="ffffff"/>
          </a:solidFill>
          <a:ln w="9360">
            <a:solidFill>
              <a:srgbClr val="33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ro-inflammatory facto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AI-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Integrin signal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33520" y="3193920"/>
            <a:ext cx="8458200" cy="615960"/>
          </a:xfrm>
          <a:custGeom>
            <a:avLst/>
            <a:gdLst>
              <a:gd name="textAreaLeft" fmla="*/ 231120 w 8458200"/>
              <a:gd name="textAreaRight" fmla="*/ 8227080 w 8458200"/>
              <a:gd name="textAreaTop" fmla="*/ 185400 h 615960"/>
              <a:gd name="textAreaBottom" fmla="*/ 430560 h 615960"/>
            </a:gdLst>
            <a:ahLst/>
            <a:rect l="textAreaLeft" t="textAreaTop" r="textAreaRight" b="textAreaBottom"/>
            <a:pathLst>
              <a:path w="21600" h="21600">
                <a:moveTo>
                  <a:pt x="0" y="6500"/>
                </a:moveTo>
                <a:lnTo>
                  <a:pt x="20116" y="6500"/>
                </a:lnTo>
                <a:lnTo>
                  <a:pt x="20116" y="0"/>
                </a:lnTo>
                <a:lnTo>
                  <a:pt x="21600" y="10800"/>
                </a:lnTo>
                <a:lnTo>
                  <a:pt x="20116" y="21600"/>
                </a:lnTo>
                <a:lnTo>
                  <a:pt x="20116" y="15100"/>
                </a:lnTo>
                <a:lnTo>
                  <a:pt x="0" y="15100"/>
                </a:lnTo>
                <a:lnTo>
                  <a:pt x="591" y="10800"/>
                </a:lnTo>
                <a:lnTo>
                  <a:pt x="0" y="6500"/>
                </a:lnTo>
                <a:close/>
              </a:path>
            </a:pathLst>
          </a:custGeom>
          <a:solidFill>
            <a:srgbClr val="000000"/>
          </a:solidFill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95800" y="3352680"/>
            <a:ext cx="183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ffffff"/>
                </a:solidFill>
                <a:latin typeface="Arial"/>
              </a:rPr>
              <a:t>       </a:t>
            </a:r>
            <a:r>
              <a:rPr b="1" lang="nl-NL" sz="1400" spc="-1" strike="noStrike">
                <a:solidFill>
                  <a:srgbClr val="ffffff"/>
                </a:solidFill>
                <a:latin typeface="Arial"/>
              </a:rPr>
              <a:t>0.5                  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278160" y="33526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ffffff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943520" y="3352680"/>
            <a:ext cx="344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400" spc="-1" strike="noStrike">
                <a:solidFill>
                  <a:srgbClr val="ffffff"/>
                </a:solidFill>
                <a:latin typeface="Arial"/>
              </a:rPr>
              <a:t>   </a:t>
            </a:r>
            <a:r>
              <a:rPr b="1" lang="nl-NL" sz="1400" spc="-1" strike="noStrike">
                <a:solidFill>
                  <a:srgbClr val="ffffff"/>
                </a:solidFill>
                <a:latin typeface="Arial"/>
              </a:rPr>
              <a:t>4                        6</a:t>
            </a:r>
            <a:r>
              <a:rPr b="1" lang="nl-NL" sz="1400" spc="-1" strike="noStrike">
                <a:solidFill>
                  <a:srgbClr val="ffffff"/>
                </a:solidFill>
                <a:latin typeface="Arial"/>
              </a:rPr>
              <a:t>	</a:t>
            </a:r>
            <a:r>
              <a:rPr b="1" lang="nl-NL" sz="1400" spc="-1" strike="noStrike">
                <a:solidFill>
                  <a:srgbClr val="ffffff"/>
                </a:solidFill>
                <a:latin typeface="Arial"/>
              </a:rPr>
              <a:t>	</a:t>
            </a:r>
            <a:r>
              <a:rPr b="1" lang="nl-NL" sz="1400" spc="-1" strike="noStrike">
                <a:solidFill>
                  <a:srgbClr val="ffffff"/>
                </a:solidFill>
                <a:latin typeface="Arial"/>
              </a:rPr>
              <a:t>24 hr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343400" y="3809880"/>
            <a:ext cx="2438280" cy="733320"/>
          </a:xfrm>
          <a:prstGeom prst="rect">
            <a:avLst/>
          </a:prstGeom>
          <a:solidFill>
            <a:srgbClr val="ffffff"/>
          </a:solidFill>
          <a:ln w="9360">
            <a:solidFill>
              <a:srgbClr val="00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ell-cycle arrest genes,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lug, N-cadherin, Nedd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NN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11040" y="6019920"/>
            <a:ext cx="8832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dditional file 7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8-11T09:40:13Z</dcterms:created>
  <dc:creator>w.moolenaar</dc:creator>
  <dc:description/>
  <dc:language>en-US</dc:language>
  <cp:lastModifiedBy>w.moolenaar</cp:lastModifiedBy>
  <dcterms:modified xsi:type="dcterms:W3CDTF">2008-08-11T09:42:18Z</dcterms:modified>
  <cp:revision>4</cp:revision>
  <dc:subject/>
  <dc:title>Slide 1</dc:title>
</cp:coreProperties>
</file>